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542" r:id="rId2"/>
    <p:sldId id="548" r:id="rId3"/>
    <p:sldId id="552" r:id="rId4"/>
    <p:sldId id="54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176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pura\Desktop\Q-PCR%20data\Nb%20AGO2,%20PAL1,%20NPR1%20KD%20revis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pura\Desktop\Q-PCR%20data\200201AGO2i-UK3,%20-8,%20H%20%20WT-UK3,%20-8,%20WT-H%20AGO2%20accumulation%2015dpi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pura\Desktop\Q-PCR%20data\200312%20AGO2%20UK3%208%20AGO1a%20accumulat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pura\Desktop\Q-PCR%20data\200314%20AGO%20MM%20UK3%208%20healthy%20AGO1b%20accumulatio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031569822701666"/>
          <c:y val="5.3047114343301789E-2"/>
          <c:w val="0.62474335445747353"/>
          <c:h val="0.835080052918009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7!$B$27</c:f>
              <c:strCache>
                <c:ptCount val="1"/>
                <c:pt idx="0">
                  <c:v>NbAGO2IR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Sheet7!$D$28:$D$30</c:f>
                <c:numCache>
                  <c:formatCode>General</c:formatCode>
                  <c:ptCount val="3"/>
                  <c:pt idx="0">
                    <c:v>8.0154139020825202E-2</c:v>
                  </c:pt>
                  <c:pt idx="1">
                    <c:v>0.11382069508999995</c:v>
                  </c:pt>
                  <c:pt idx="2">
                    <c:v>0.13614631096260027</c:v>
                  </c:pt>
                </c:numCache>
              </c:numRef>
            </c:plus>
            <c:minus>
              <c:numRef>
                <c:f>Sheet7!$D$28:$D$30</c:f>
                <c:numCache>
                  <c:formatCode>General</c:formatCode>
                  <c:ptCount val="3"/>
                  <c:pt idx="0">
                    <c:v>8.0154139020825202E-2</c:v>
                  </c:pt>
                  <c:pt idx="1">
                    <c:v>0.11382069508999995</c:v>
                  </c:pt>
                  <c:pt idx="2">
                    <c:v>0.136146310962600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7!$A$28:$A$30</c:f>
              <c:strCache>
                <c:ptCount val="3"/>
                <c:pt idx="0">
                  <c:v>3dpi</c:v>
                </c:pt>
                <c:pt idx="1">
                  <c:v>5dpi</c:v>
                </c:pt>
                <c:pt idx="2">
                  <c:v>7dpi</c:v>
                </c:pt>
              </c:strCache>
            </c:strRef>
          </c:cat>
          <c:val>
            <c:numRef>
              <c:f>Sheet7!$B$28:$B$30</c:f>
              <c:numCache>
                <c:formatCode>General</c:formatCode>
                <c:ptCount val="3"/>
                <c:pt idx="0">
                  <c:v>0.27972901325554206</c:v>
                </c:pt>
                <c:pt idx="1">
                  <c:v>0.19844863323692427</c:v>
                </c:pt>
                <c:pt idx="2">
                  <c:v>0.2845505060161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4F-47CA-BCE9-818678506C71}"/>
            </c:ext>
          </c:extLst>
        </c:ser>
        <c:ser>
          <c:idx val="1"/>
          <c:order val="1"/>
          <c:tx>
            <c:strRef>
              <c:f>Sheet7!$C$27</c:f>
              <c:strCache>
                <c:ptCount val="1"/>
                <c:pt idx="0">
                  <c:v>WT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Sheet7!$E$28:$E$30</c:f>
                <c:numCache>
                  <c:formatCode>General</c:formatCode>
                  <c:ptCount val="3"/>
                  <c:pt idx="0">
                    <c:v>0.16401279367206198</c:v>
                  </c:pt>
                  <c:pt idx="1">
                    <c:v>0.2965506465475537</c:v>
                  </c:pt>
                  <c:pt idx="2">
                    <c:v>0.28612603147112076</c:v>
                  </c:pt>
                </c:numCache>
              </c:numRef>
            </c:plus>
            <c:minus>
              <c:numRef>
                <c:f>Sheet7!$E$28:$E$30</c:f>
                <c:numCache>
                  <c:formatCode>General</c:formatCode>
                  <c:ptCount val="3"/>
                  <c:pt idx="0">
                    <c:v>0.16401279367206198</c:v>
                  </c:pt>
                  <c:pt idx="1">
                    <c:v>0.2965506465475537</c:v>
                  </c:pt>
                  <c:pt idx="2">
                    <c:v>0.286126031471120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7!$A$28:$A$30</c:f>
              <c:strCache>
                <c:ptCount val="3"/>
                <c:pt idx="0">
                  <c:v>3dpi</c:v>
                </c:pt>
                <c:pt idx="1">
                  <c:v>5dpi</c:v>
                </c:pt>
                <c:pt idx="2">
                  <c:v>7dpi</c:v>
                </c:pt>
              </c:strCache>
            </c:strRef>
          </c:cat>
          <c:val>
            <c:numRef>
              <c:f>Sheet7!$C$28:$C$30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84F-47CA-BCE9-818678506C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3141176"/>
        <c:axId val="583140520"/>
      </c:barChart>
      <c:catAx>
        <c:axId val="583141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83140520"/>
        <c:crosses val="autoZero"/>
        <c:auto val="1"/>
        <c:lblAlgn val="ctr"/>
        <c:lblOffset val="100"/>
        <c:noMultiLvlLbl val="0"/>
      </c:catAx>
      <c:valAx>
        <c:axId val="5831405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lang="ja-JP" sz="7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Relative expression</a:t>
                </a:r>
              </a:p>
              <a:p>
                <a:pPr algn="ctr" rtl="0">
                  <a:defRPr lang="ja-JP" b="1"/>
                </a:pPr>
                <a:r>
                  <a:rPr lang="en-US" b="1"/>
                  <a:t>(NbAGO2/18S)</a:t>
                </a:r>
                <a:endParaRPr lang="ko-KR" b="1"/>
              </a:p>
              <a:p>
                <a:pPr algn="ctr" rtl="0">
                  <a:defRPr lang="ja-JP" b="1"/>
                </a:pPr>
                <a:endParaRPr lang="ko-KR" b="1"/>
              </a:p>
            </c:rich>
          </c:tx>
          <c:layout>
            <c:manualLayout>
              <c:xMode val="edge"/>
              <c:yMode val="edge"/>
              <c:x val="3.1777414181282736E-2"/>
              <c:y val="0.298109768271808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lang="ja-JP" sz="7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831411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009385451726332"/>
          <c:y val="0.42633634880443488"/>
          <c:w val="0.15480122765345222"/>
          <c:h val="0.1627593309000770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A$23</c:f>
              <c:strCache>
                <c:ptCount val="1"/>
                <c:pt idx="0">
                  <c:v>AGO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bg1">
                    <a:lumMod val="8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5512-438C-AB76-7663988A8D82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bg1">
                    <a:lumMod val="8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512-438C-AB76-7663988A8D82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bg1">
                    <a:lumMod val="8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5512-438C-AB76-7663988A8D82}"/>
              </c:ext>
            </c:extLst>
          </c:dPt>
          <c:errBars>
            <c:errBarType val="both"/>
            <c:errValType val="cust"/>
            <c:noEndCap val="1"/>
            <c:plus>
              <c:numRef>
                <c:f>Sheet7!$B$24:$G$24</c:f>
                <c:numCache>
                  <c:formatCode>General</c:formatCode>
                  <c:ptCount val="6"/>
                  <c:pt idx="0">
                    <c:v>0.19249990933850103</c:v>
                  </c:pt>
                  <c:pt idx="1">
                    <c:v>9.3230675103137928E-2</c:v>
                  </c:pt>
                  <c:pt idx="2">
                    <c:v>0.26854131895609973</c:v>
                  </c:pt>
                  <c:pt idx="3">
                    <c:v>0.1968062686724254</c:v>
                  </c:pt>
                  <c:pt idx="4">
                    <c:v>0.15003729324945142</c:v>
                  </c:pt>
                  <c:pt idx="5">
                    <c:v>0.2485595962833427</c:v>
                  </c:pt>
                </c:numCache>
              </c:numRef>
            </c:plus>
            <c:minus>
              <c:numRef>
                <c:f>Sheet7!$B$24:$G$24</c:f>
                <c:numCache>
                  <c:formatCode>General</c:formatCode>
                  <c:ptCount val="6"/>
                  <c:pt idx="0">
                    <c:v>0.19249990933850103</c:v>
                  </c:pt>
                  <c:pt idx="1">
                    <c:v>9.3230675103137928E-2</c:v>
                  </c:pt>
                  <c:pt idx="2">
                    <c:v>0.26854131895609973</c:v>
                  </c:pt>
                  <c:pt idx="3">
                    <c:v>0.1968062686724254</c:v>
                  </c:pt>
                  <c:pt idx="4">
                    <c:v>0.15003729324945142</c:v>
                  </c:pt>
                  <c:pt idx="5">
                    <c:v>0.24855959628334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7!$B$22:$G$22</c:f>
              <c:strCache>
                <c:ptCount val="6"/>
                <c:pt idx="0">
                  <c:v>UK3</c:v>
                </c:pt>
                <c:pt idx="1">
                  <c:v>8Mt</c:v>
                </c:pt>
                <c:pt idx="2">
                  <c:v>Mock</c:v>
                </c:pt>
                <c:pt idx="3">
                  <c:v>UK3</c:v>
                </c:pt>
                <c:pt idx="4">
                  <c:v>8Mt</c:v>
                </c:pt>
                <c:pt idx="5">
                  <c:v>Mock</c:v>
                </c:pt>
              </c:strCache>
            </c:strRef>
          </c:cat>
          <c:val>
            <c:numRef>
              <c:f>Sheet7!$B$23:$G$23</c:f>
              <c:numCache>
                <c:formatCode>General</c:formatCode>
                <c:ptCount val="6"/>
                <c:pt idx="0">
                  <c:v>0.5810906241644096</c:v>
                </c:pt>
                <c:pt idx="1">
                  <c:v>0.44126098391516216</c:v>
                </c:pt>
                <c:pt idx="2">
                  <c:v>0.56124793691590569</c:v>
                </c:pt>
                <c:pt idx="3">
                  <c:v>1.0693600194958535</c:v>
                </c:pt>
                <c:pt idx="4">
                  <c:v>0.88176544739610063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31-44FA-B3CE-83683D0C93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2829320"/>
        <c:axId val="362830304"/>
      </c:barChart>
      <c:catAx>
        <c:axId val="362829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62830304"/>
        <c:crosses val="autoZero"/>
        <c:auto val="1"/>
        <c:lblAlgn val="ctr"/>
        <c:lblOffset val="100"/>
        <c:noMultiLvlLbl val="0"/>
      </c:catAx>
      <c:valAx>
        <c:axId val="362830304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1"/>
                  <a:t>Relative expression</a:t>
                </a:r>
                <a:endParaRPr lang="ko-KR" sz="800" b="1"/>
              </a:p>
              <a:p>
                <a:pPr>
                  <a:defRPr lang="ja-JP" sz="800" b="1"/>
                </a:pPr>
                <a:r>
                  <a:rPr lang="en-US" sz="800" b="1"/>
                  <a:t>(SlAGO2/18S)</a:t>
                </a:r>
                <a:endParaRPr lang="ko-KR" sz="8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62829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A$14</c:f>
              <c:strCache>
                <c:ptCount val="1"/>
                <c:pt idx="0">
                  <c:v>AGO1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50D-4FA9-898F-40F7D98E6DC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50D-4FA9-898F-40F7D98E6DCD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50D-4FA9-898F-40F7D98E6DCD}"/>
              </c:ext>
            </c:extLst>
          </c:dPt>
          <c:errBars>
            <c:errBarType val="both"/>
            <c:errValType val="cust"/>
            <c:noEndCap val="1"/>
            <c:plus>
              <c:numRef>
                <c:f>Sheet7!$B$15:$G$15</c:f>
                <c:numCache>
                  <c:formatCode>General</c:formatCode>
                  <c:ptCount val="6"/>
                  <c:pt idx="0">
                    <c:v>9.0077982719620919E-2</c:v>
                  </c:pt>
                  <c:pt idx="1">
                    <c:v>9.0077982719620919E-2</c:v>
                  </c:pt>
                  <c:pt idx="2">
                    <c:v>9.0077982719620919E-2</c:v>
                  </c:pt>
                  <c:pt idx="3">
                    <c:v>0.11630365283545144</c:v>
                  </c:pt>
                  <c:pt idx="4">
                    <c:v>0.33162463647481039</c:v>
                  </c:pt>
                  <c:pt idx="5">
                    <c:v>9.5144762548853234E-2</c:v>
                  </c:pt>
                </c:numCache>
              </c:numRef>
            </c:plus>
            <c:minus>
              <c:numRef>
                <c:f>Sheet7!$B$15:$G$15</c:f>
                <c:numCache>
                  <c:formatCode>General</c:formatCode>
                  <c:ptCount val="6"/>
                  <c:pt idx="0">
                    <c:v>9.0077982719620919E-2</c:v>
                  </c:pt>
                  <c:pt idx="1">
                    <c:v>9.0077982719620919E-2</c:v>
                  </c:pt>
                  <c:pt idx="2">
                    <c:v>9.0077982719620919E-2</c:v>
                  </c:pt>
                  <c:pt idx="3">
                    <c:v>0.11630365283545144</c:v>
                  </c:pt>
                  <c:pt idx="4">
                    <c:v>0.33162463647481039</c:v>
                  </c:pt>
                  <c:pt idx="5">
                    <c:v>9.514476254885323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7!$B$13:$G$13</c:f>
              <c:strCache>
                <c:ptCount val="6"/>
                <c:pt idx="0">
                  <c:v>UK3</c:v>
                </c:pt>
                <c:pt idx="1">
                  <c:v>8Mt</c:v>
                </c:pt>
                <c:pt idx="2">
                  <c:v>Mock</c:v>
                </c:pt>
                <c:pt idx="3">
                  <c:v>UK3</c:v>
                </c:pt>
                <c:pt idx="4">
                  <c:v>8Mt</c:v>
                </c:pt>
                <c:pt idx="5">
                  <c:v>Mock</c:v>
                </c:pt>
              </c:strCache>
            </c:strRef>
          </c:cat>
          <c:val>
            <c:numRef>
              <c:f>Sheet7!$B$14:$G$14</c:f>
              <c:numCache>
                <c:formatCode>General</c:formatCode>
                <c:ptCount val="6"/>
                <c:pt idx="0">
                  <c:v>0.95057046509242005</c:v>
                </c:pt>
                <c:pt idx="1">
                  <c:v>0.95057046509242005</c:v>
                </c:pt>
                <c:pt idx="2">
                  <c:v>1</c:v>
                </c:pt>
                <c:pt idx="3">
                  <c:v>1.1681823014496049</c:v>
                </c:pt>
                <c:pt idx="4">
                  <c:v>1.3243127023643029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50D-4FA9-898F-40F7D98E6D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64112632"/>
        <c:axId val="564118208"/>
      </c:barChart>
      <c:catAx>
        <c:axId val="564112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4118208"/>
        <c:crosses val="autoZero"/>
        <c:auto val="1"/>
        <c:lblAlgn val="ctr"/>
        <c:lblOffset val="100"/>
        <c:noMultiLvlLbl val="0"/>
      </c:catAx>
      <c:valAx>
        <c:axId val="564118208"/>
        <c:scaling>
          <c:orientation val="minMax"/>
          <c:max val="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1"/>
                  <a:t>Relative expression</a:t>
                </a:r>
                <a:endParaRPr lang="ko-KR" sz="800" b="1"/>
              </a:p>
              <a:p>
                <a:pPr>
                  <a:defRPr lang="ja-JP" sz="800" b="1"/>
                </a:pPr>
                <a:r>
                  <a:rPr lang="en-US" sz="800" b="1"/>
                  <a:t>(SlAGO1a/18S)</a:t>
                </a:r>
                <a:endParaRPr lang="ko-KR" sz="8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4112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7!$A$30</c:f>
              <c:strCache>
                <c:ptCount val="1"/>
                <c:pt idx="0">
                  <c:v>AGO1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01C-4E03-8B67-9589331EC41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01C-4E03-8B67-9589331EC418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01C-4E03-8B67-9589331EC418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01C-4E03-8B67-9589331EC418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01C-4E03-8B67-9589331EC418}"/>
              </c:ext>
            </c:extLst>
          </c:dPt>
          <c:dPt>
            <c:idx val="5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501C-4E03-8B67-9589331EC418}"/>
              </c:ext>
            </c:extLst>
          </c:dPt>
          <c:errBars>
            <c:errBarType val="both"/>
            <c:errValType val="cust"/>
            <c:noEndCap val="1"/>
            <c:plus>
              <c:numRef>
                <c:f>Sheet7!$B$31:$G$31</c:f>
                <c:numCache>
                  <c:formatCode>General</c:formatCode>
                  <c:ptCount val="6"/>
                  <c:pt idx="0">
                    <c:v>3.6574231853162359E-2</c:v>
                  </c:pt>
                  <c:pt idx="1">
                    <c:v>0.14401972658240544</c:v>
                  </c:pt>
                  <c:pt idx="2">
                    <c:v>0.16246422115799508</c:v>
                  </c:pt>
                  <c:pt idx="3">
                    <c:v>7.7118767329069249E-2</c:v>
                  </c:pt>
                  <c:pt idx="4">
                    <c:v>7.0690220556793387E-2</c:v>
                  </c:pt>
                  <c:pt idx="5">
                    <c:v>0.18154175466777758</c:v>
                  </c:pt>
                </c:numCache>
              </c:numRef>
            </c:plus>
            <c:minus>
              <c:numRef>
                <c:f>Sheet7!$B$31:$G$31</c:f>
                <c:numCache>
                  <c:formatCode>General</c:formatCode>
                  <c:ptCount val="6"/>
                  <c:pt idx="0">
                    <c:v>3.6574231853162359E-2</c:v>
                  </c:pt>
                  <c:pt idx="1">
                    <c:v>0.14401972658240544</c:v>
                  </c:pt>
                  <c:pt idx="2">
                    <c:v>0.16246422115799508</c:v>
                  </c:pt>
                  <c:pt idx="3">
                    <c:v>7.7118767329069249E-2</c:v>
                  </c:pt>
                  <c:pt idx="4">
                    <c:v>7.0690220556793387E-2</c:v>
                  </c:pt>
                  <c:pt idx="5">
                    <c:v>0.181541754667777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7!$B$29:$G$29</c:f>
              <c:strCache>
                <c:ptCount val="6"/>
                <c:pt idx="0">
                  <c:v>UK3</c:v>
                </c:pt>
                <c:pt idx="1">
                  <c:v>8Mt</c:v>
                </c:pt>
                <c:pt idx="2">
                  <c:v>Mock</c:v>
                </c:pt>
                <c:pt idx="3">
                  <c:v>UK3</c:v>
                </c:pt>
                <c:pt idx="4">
                  <c:v>8Mt</c:v>
                </c:pt>
                <c:pt idx="5">
                  <c:v>Mock</c:v>
                </c:pt>
              </c:strCache>
            </c:strRef>
          </c:cat>
          <c:val>
            <c:numRef>
              <c:f>Sheet7!$B$30:$G$30</c:f>
              <c:numCache>
                <c:formatCode>General</c:formatCode>
                <c:ptCount val="6"/>
                <c:pt idx="0">
                  <c:v>0.9506342780517737</c:v>
                </c:pt>
                <c:pt idx="1">
                  <c:v>0.78011758246563068</c:v>
                </c:pt>
                <c:pt idx="2">
                  <c:v>1</c:v>
                </c:pt>
                <c:pt idx="3">
                  <c:v>0.93744365254587636</c:v>
                </c:pt>
                <c:pt idx="4">
                  <c:v>0.81907400118691076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01C-4E03-8B67-9589331EC4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8016040"/>
        <c:axId val="548017024"/>
      </c:barChart>
      <c:catAx>
        <c:axId val="548016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48017024"/>
        <c:crosses val="autoZero"/>
        <c:auto val="1"/>
        <c:lblAlgn val="ctr"/>
        <c:lblOffset val="100"/>
        <c:noMultiLvlLbl val="0"/>
      </c:catAx>
      <c:valAx>
        <c:axId val="548017024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8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1"/>
                  <a:t>Relative expression</a:t>
                </a:r>
                <a:endParaRPr lang="ko-KR" sz="800" b="1"/>
              </a:p>
              <a:p>
                <a:pPr>
                  <a:defRPr lang="ja-JP" sz="800" b="1"/>
                </a:pPr>
                <a:r>
                  <a:rPr lang="en-US" sz="800" b="1"/>
                  <a:t>(SlAGO1b/18S)</a:t>
                </a:r>
                <a:endParaRPr lang="ko-KR" sz="8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8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48016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02D06D-0E8B-4069-A9E2-3DBC21DAA5A5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54B301-23F2-41DA-8526-8A5C7E71D5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9264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머리글 개체 틀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fld id="{2EC5044D-959C-4F83-9EF0-D8E978BC2710}" type="datetime1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6F3D8D-4C4D-4E5E-B8E9-3BFCE299A005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52974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89038" y="1252538"/>
            <a:ext cx="4510087" cy="3381375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머리글 개체 틀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fld id="{2EC5044D-959C-4F83-9EF0-D8E978BC2710}" type="datetime1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6F3D8D-4C4D-4E5E-B8E9-3BFCE299A005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44217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1575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2133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7140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4233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4758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0385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5176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6915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5924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057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4218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B292E-5B77-4EC6-AEBB-049C25B4ECDD}" type="datetimeFigureOut">
              <a:rPr lang="ko-KR" altLang="en-US" smtClean="0"/>
              <a:t>2024. 5. 20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306D7-B30A-4568-B941-F436A8E743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9768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.xml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7.wdp"/><Relationship Id="rId18" Type="http://schemas.openxmlformats.org/officeDocument/2006/relationships/image" Target="../media/image10.png"/><Relationship Id="rId3" Type="http://schemas.microsoft.com/office/2007/relationships/hdphoto" Target="../media/hdphoto2.wdp"/><Relationship Id="rId7" Type="http://schemas.microsoft.com/office/2007/relationships/hdphoto" Target="../media/hdphoto4.wdp"/><Relationship Id="rId12" Type="http://schemas.openxmlformats.org/officeDocument/2006/relationships/image" Target="../media/image7.png"/><Relationship Id="rId17" Type="http://schemas.microsoft.com/office/2007/relationships/hdphoto" Target="../media/hdphoto9.wdp"/><Relationship Id="rId2" Type="http://schemas.openxmlformats.org/officeDocument/2006/relationships/image" Target="../media/image2.png"/><Relationship Id="rId16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microsoft.com/office/2007/relationships/hdphoto" Target="../media/hdphoto6.wdp"/><Relationship Id="rId5" Type="http://schemas.microsoft.com/office/2007/relationships/hdphoto" Target="../media/hdphoto3.wdp"/><Relationship Id="rId15" Type="http://schemas.microsoft.com/office/2007/relationships/hdphoto" Target="../media/hdphoto8.wdp"/><Relationship Id="rId10" Type="http://schemas.openxmlformats.org/officeDocument/2006/relationships/image" Target="../media/image6.png"/><Relationship Id="rId19" Type="http://schemas.microsoft.com/office/2007/relationships/hdphoto" Target="../media/hdphoto10.wdp"/><Relationship Id="rId4" Type="http://schemas.openxmlformats.org/officeDocument/2006/relationships/image" Target="../media/image3.png"/><Relationship Id="rId9" Type="http://schemas.microsoft.com/office/2007/relationships/hdphoto" Target="../media/hdphoto5.wdp"/><Relationship Id="rId1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A01E4E-6AAF-4DE8-B6E1-D5941F33CF58}"/>
              </a:ext>
            </a:extLst>
          </p:cNvPr>
          <p:cNvSpPr txBox="1"/>
          <p:nvPr/>
        </p:nvSpPr>
        <p:spPr>
          <a:xfrm>
            <a:off x="0" y="263769"/>
            <a:ext cx="1970411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85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endParaRPr lang="ko-KR" altLang="en-US" sz="13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C4BF6D99-73E3-49C1-97B9-423B49A30B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3422047"/>
              </p:ext>
            </p:extLst>
          </p:nvPr>
        </p:nvGraphicFramePr>
        <p:xfrm>
          <a:off x="3286095" y="1311425"/>
          <a:ext cx="2571812" cy="3128706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876198">
                  <a:extLst>
                    <a:ext uri="{9D8B030D-6E8A-4147-A177-3AD203B41FA5}">
                      <a16:colId xmlns:a16="http://schemas.microsoft.com/office/drawing/2014/main" val="1030098376"/>
                    </a:ext>
                  </a:extLst>
                </a:gridCol>
                <a:gridCol w="1695614">
                  <a:extLst>
                    <a:ext uri="{9D8B030D-6E8A-4147-A177-3AD203B41FA5}">
                      <a16:colId xmlns:a16="http://schemas.microsoft.com/office/drawing/2014/main" val="3972209262"/>
                    </a:ext>
                  </a:extLst>
                </a:gridCol>
              </a:tblGrid>
              <a:tr h="169290">
                <a:tc gridSpan="2"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tabLst/>
                      </a:pP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.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s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ed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NA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RT</a:t>
                      </a:r>
                      <a:r>
                        <a:rPr lang="en-US" altLang="zh-CN" sz="6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CR</a:t>
                      </a:r>
                    </a:p>
                  </a:txBody>
                  <a:tcPr marL="38577" marR="38577" marT="19289" marB="19289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굴림체" panose="020B0609000101010101" pitchFamily="49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745634"/>
                  </a:ext>
                </a:extLst>
              </a:tr>
              <a:tr h="140770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tabLst>
                          <a:tab pos="25400" algn="l"/>
                        </a:tabLst>
                      </a:pP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</a:p>
                  </a:txBody>
                  <a:tcPr marL="4018" marR="4018" marT="40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tabLst>
                          <a:tab pos="25400" algn="l"/>
                        </a:tabLst>
                      </a:pP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cleotide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′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→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′</a:t>
                      </a:r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6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altLang="zh-CN" sz="600" b="1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018" marR="4018" marT="40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4425847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SOD1-F</a:t>
                      </a:r>
                    </a:p>
                  </a:txBody>
                  <a:tcPr marL="30272" marR="28933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CTGGACTTCATGGCTTC</a:t>
                      </a:r>
                    </a:p>
                  </a:txBody>
                  <a:tcPr marL="30272" marR="28933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SOD1-R</a:t>
                      </a: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GCAGGATTGTAATGTGG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SOD2-F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CTCCGGGAACGATAGTG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SOD2-R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GCATGGATATGGAAAGC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2911089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SOD3-F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CTGGAGATGAAATCCGT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SOD3-R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TGCTCGTCCAACAACTG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139248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SOD4-F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CCGATAATGGAGTCGTT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4933192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SOD4-R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TTGCAATTTGCTCTTGA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3898381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18SrRNA-F</a:t>
                      </a:r>
                      <a:endParaRPr lang="ko-KR" altLang="ko-KR" sz="500" b="1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GTTCTTAGTTGGTGGAGCGAT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406260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18SrRNA-R</a:t>
                      </a:r>
                      <a:endParaRPr lang="ko-KR" altLang="ko-KR" sz="500" b="1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CATAGTCCCTCTAAGAAGCTG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0736213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X-47nt (</a:t>
                      </a:r>
                      <a:r>
                        <a:rPr lang="en-US" altLang="zh-CN" sz="500" i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n</a:t>
                      </a:r>
                      <a:r>
                        <a:rPr lang="en-US" altLang="zh-CN" sz="500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F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GCC</a:t>
                      </a:r>
                      <a:r>
                        <a:rPr lang="en-US" altLang="zh-CN" sz="5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TTG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CACACC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0914770"/>
                  </a:ext>
                </a:extLst>
              </a:tr>
              <a:tr h="103695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X-3940nt (</a:t>
                      </a:r>
                      <a:r>
                        <a:rPr lang="en-US" altLang="zh-CN" sz="500" i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n</a:t>
                      </a:r>
                      <a:r>
                        <a:rPr lang="en-US" altLang="zh-CN" sz="500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R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GTG</a:t>
                      </a:r>
                      <a:r>
                        <a:rPr lang="en-US" altLang="zh-CN" sz="5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AGG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ATCTG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1045745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X-3940nt (</a:t>
                      </a:r>
                      <a:r>
                        <a:rPr lang="en-US" altLang="zh-CN" sz="500" i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n</a:t>
                      </a:r>
                      <a:r>
                        <a:rPr lang="en-US" altLang="zh-CN" sz="500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F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ATTTT</a:t>
                      </a:r>
                      <a:r>
                        <a:rPr lang="en-US" altLang="zh-CN" sz="5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AGG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ATT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5133176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X-5146nt (</a:t>
                      </a:r>
                      <a:r>
                        <a:rPr lang="en-US" altLang="zh-CN" sz="500" i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e</a:t>
                      </a:r>
                      <a:r>
                        <a:rPr lang="en-US" altLang="zh-CN" sz="500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R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TGCGCGGA</a:t>
                      </a:r>
                      <a:r>
                        <a:rPr lang="en-US" altLang="zh-CN" sz="5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TG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3481387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X-5146nt (</a:t>
                      </a:r>
                      <a:r>
                        <a:rPr lang="en-US" altLang="zh-CN" sz="500" i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e</a:t>
                      </a:r>
                      <a:r>
                        <a:rPr lang="en-US" altLang="zh-CN" sz="500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F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</a:t>
                      </a:r>
                      <a:r>
                        <a:rPr lang="en-US" altLang="zh-CN" sz="5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TG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GCGCAGGG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0357068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X-6380nt (</a:t>
                      </a:r>
                      <a:r>
                        <a:rPr lang="en-US" altLang="zh-CN" sz="500" i="1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ho</a:t>
                      </a:r>
                      <a:r>
                        <a:rPr lang="en-US" altLang="zh-CN" sz="500" dirty="0" err="1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-R 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GAC</a:t>
                      </a:r>
                      <a:r>
                        <a:rPr lang="en-US" altLang="zh-CN" sz="5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GAG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CAGCT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9089600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dRp-D1422E-F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AAACAGTGTCAGGCACATACACTC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8254147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5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dRp-D1422E-R</a:t>
                      </a:r>
                      <a:endParaRPr lang="ko-KR" alt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ATCGAATAGTTCATGCAGAGAGT</a:t>
                      </a:r>
                      <a:endParaRPr lang="ko-KR" sz="5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3343563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bAGO2IR-F</a:t>
                      </a:r>
                      <a:endParaRPr lang="ko-KR" alt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GAATTCCATATG GAGCACTTGGCTGAACATGA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0687866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bAGO2IR-R</a:t>
                      </a:r>
                      <a:endParaRPr lang="ko-KR" alt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AGTCAGTGGCCAAA TCTTCAGCCCGTACCATTTC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0390540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bAGO2IR-anti-F</a:t>
                      </a:r>
                      <a:endParaRPr lang="ko-KR" alt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CGCGTCGAC GAGCACTTGGCTGAACATGA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5221229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bAGO2IR-anti-R</a:t>
                      </a:r>
                      <a:endParaRPr lang="ko-KR" alt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TTGGCCACTGACTG TCTTCAGCCCGTACCATTTC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5693812"/>
                  </a:ext>
                </a:extLst>
              </a:tr>
              <a:tr h="15430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i="1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la</a:t>
                      </a: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I-Flag-SlSOD4-F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CA</a:t>
                      </a:r>
                      <a:r>
                        <a:rPr lang="en-US" altLang="ko-KR" sz="500" b="1" u="none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TCGAT</a:t>
                      </a:r>
                      <a:r>
                        <a:rPr lang="en-US" altLang="ko-KR" sz="500" b="0" i="1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TGGACTACAAAGACGATGACGAC AAG</a:t>
                      </a:r>
                      <a:r>
                        <a:rPr lang="en-US" altLang="ko-KR" sz="500" b="0" i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TGGCATTTTTGAGGTCCATTGTGAC</a:t>
                      </a:r>
                      <a:endParaRPr lang="ko-KR" sz="500" b="0" i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3911309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i="1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al</a:t>
                      </a: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I-SlSOD4-R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GG</a:t>
                      </a:r>
                      <a:r>
                        <a:rPr lang="en-US" altLang="ko-KR" sz="500" b="1" u="none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TCGAC</a:t>
                      </a: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CAGATTTTGCTGGTTGCTTCCCAG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428808"/>
                  </a:ext>
                </a:extLst>
              </a:tr>
              <a:tr h="90559"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VX genomic RNA probe-F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 latinLnBrk="1">
                        <a:spcAft>
                          <a:spcPts val="0"/>
                        </a:spcAft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TGTCAGCACCAGCTAGCACAACA</a:t>
                      </a:r>
                      <a:endParaRPr 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5863013"/>
                  </a:ext>
                </a:extLst>
              </a:tr>
              <a:tr h="154309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500" b="0" dirty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VX genomic RNA probe-R</a:t>
                      </a:r>
                      <a:endParaRPr lang="ko-KR" altLang="ko-KR" sz="500" b="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TC</a:t>
                      </a:r>
                      <a:r>
                        <a:rPr lang="en-US" altLang="zh-CN" sz="500" b="0" i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ATACGACTCACTATAGGG</a:t>
                      </a:r>
                      <a:r>
                        <a:rPr lang="en-US" altLang="zh-CN" sz="5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TTATGGTGGTAGCGTGAC</a:t>
                      </a:r>
                    </a:p>
                  </a:txBody>
                  <a:tcPr marL="30272" marR="28933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573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5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lPR1a probe-F</a:t>
                      </a:r>
                      <a:endParaRPr lang="ko-KR" altLang="ko-KR" sz="5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8577" marR="38577" marT="19289" marB="1928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체" panose="020B0609000101010101" pitchFamily="49" charset="-127"/>
                          <a:cs typeface="Arial" panose="020B0604020202020204" pitchFamily="34" charset="0"/>
                        </a:rPr>
                        <a:t>GAATTCATGCAAAATTCACCCC</a:t>
                      </a:r>
                    </a:p>
                  </a:txBody>
                  <a:tcPr marL="38577" marR="38577" marT="19289" marB="1928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7619144"/>
                  </a:ext>
                </a:extLst>
              </a:tr>
              <a:tr h="192886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5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lPR1a probe-R</a:t>
                      </a:r>
                      <a:endParaRPr lang="ko-KR" altLang="ko-KR" sz="5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8577" marR="38577" marT="19289" marB="1928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체" panose="020B0609000101010101" pitchFamily="49" charset="-127"/>
                          <a:cs typeface="Arial" panose="020B0604020202020204" pitchFamily="34" charset="0"/>
                        </a:rPr>
                        <a:t>AATTC</a:t>
                      </a:r>
                      <a:r>
                        <a:rPr lang="en-US" altLang="ko-KR" sz="5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체" panose="020B0609000101010101" pitchFamily="49" charset="-127"/>
                          <a:cs typeface="Arial" panose="020B0604020202020204" pitchFamily="34" charset="0"/>
                        </a:rPr>
                        <a:t>TAATACGACTCACTATAGGG</a:t>
                      </a:r>
                      <a:r>
                        <a:rPr lang="en-US" altLang="ko-KR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굴림체" panose="020B0609000101010101" pitchFamily="49" charset="-127"/>
                          <a:cs typeface="Arial" panose="020B0604020202020204" pitchFamily="34" charset="0"/>
                        </a:rPr>
                        <a:t>CTCGAGTTAGTAAGGACGTTG</a:t>
                      </a:r>
                    </a:p>
                  </a:txBody>
                  <a:tcPr marL="38577" marR="38577" marT="19289" marB="1928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949674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CC198BD-7C8D-464D-9EC2-2B7B1B896F62}"/>
              </a:ext>
            </a:extLst>
          </p:cNvPr>
          <p:cNvSpPr txBox="1"/>
          <p:nvPr/>
        </p:nvSpPr>
        <p:spPr>
          <a:xfrm>
            <a:off x="3205015" y="4440131"/>
            <a:ext cx="2652892" cy="2637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422"/>
              </a:spcAft>
            </a:pPr>
            <a:r>
              <a:rPr lang="en" altLang="ko-KR" sz="506" kern="100" baseline="30000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1 </a:t>
            </a:r>
            <a:r>
              <a:rPr lang="en" altLang="ko-KR" sz="506" kern="100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Restriction enzyme sites are in bold; Flag tag and T7 promoter sequences are italicized.</a:t>
            </a:r>
            <a:endParaRPr lang="ko-KR" altLang="ko-KR" sz="506" kern="100" dirty="0"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1660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DD2A3CF-0C3B-43D2-90CA-4D7B33A8F1BD}"/>
              </a:ext>
            </a:extLst>
          </p:cNvPr>
          <p:cNvSpPr txBox="1"/>
          <p:nvPr/>
        </p:nvSpPr>
        <p:spPr>
          <a:xfrm>
            <a:off x="0" y="18574"/>
            <a:ext cx="220765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85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altLang="ko-KR" sz="1385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385" kern="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34" charset="-127"/>
                <a:cs typeface="Arial" panose="020B0604020202020204" pitchFamily="34" charset="0"/>
              </a:rPr>
              <a:t>Figure S1</a:t>
            </a:r>
            <a:endParaRPr lang="ko-KR" altLang="en-US" sz="138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표 2">
            <a:extLst>
              <a:ext uri="{FF2B5EF4-FFF2-40B4-BE49-F238E27FC236}">
                <a16:creationId xmlns:a16="http://schemas.microsoft.com/office/drawing/2014/main" id="{FCD7BCA8-94C4-4730-8397-E755E161D723}"/>
              </a:ext>
            </a:extLst>
          </p:cNvPr>
          <p:cNvGraphicFramePr>
            <a:graphicFrameLocks noGrp="1"/>
          </p:cNvGraphicFramePr>
          <p:nvPr/>
        </p:nvGraphicFramePr>
        <p:xfrm>
          <a:off x="1229752" y="1864776"/>
          <a:ext cx="2989385" cy="1905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28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004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142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7521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0791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1156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latinLnBrk="1"/>
                      <a:endParaRPr lang="ko-KR" altLang="en-US" sz="900"/>
                    </a:p>
                  </a:txBody>
                  <a:tcPr marL="47490" marR="47490" marT="23781" marB="23781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900" dirty="0"/>
                    </a:p>
                  </a:txBody>
                  <a:tcPr marL="47490" marR="47490" marT="23781" marB="23781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900" dirty="0"/>
                    </a:p>
                  </a:txBody>
                  <a:tcPr marL="47490" marR="47490" marT="23781" marB="23781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900" dirty="0"/>
                    </a:p>
                  </a:txBody>
                  <a:tcPr marL="47490" marR="47490" marT="23781" marB="23781"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900" dirty="0"/>
                    </a:p>
                  </a:txBody>
                  <a:tcPr marL="47490" marR="47490" marT="23781" marB="23781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900" dirty="0"/>
                    </a:p>
                  </a:txBody>
                  <a:tcPr marL="47490" marR="47490" marT="23781" marB="23781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680D2ABB-A845-46DB-BB4B-BF2626F373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472" y="1809091"/>
            <a:ext cx="801823" cy="316112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latinLnBrk="0">
              <a:lnSpc>
                <a:spcPct val="100000"/>
              </a:lnSpc>
              <a:spcBef>
                <a:spcPct val="0"/>
              </a:spcBef>
              <a:buNone/>
              <a:defRPr/>
            </a:pPr>
            <a:r>
              <a:rPr lang="en-US" altLang="ko-KR" sz="727" dirty="0">
                <a:latin typeface="Arial" panose="020B0604020202020204" pitchFamily="34" charset="0"/>
                <a:cs typeface="Arial" panose="020B0604020202020204" pitchFamily="34" charset="0"/>
              </a:rPr>
              <a:t>NbAGO2 </a:t>
            </a:r>
          </a:p>
          <a:p>
            <a:pPr algn="ctr" latinLnBrk="0">
              <a:lnSpc>
                <a:spcPct val="100000"/>
              </a:lnSpc>
              <a:spcBef>
                <a:spcPct val="0"/>
              </a:spcBef>
              <a:buNone/>
              <a:defRPr/>
            </a:pPr>
            <a:r>
              <a:rPr lang="en-US" altLang="ko-KR" sz="727" dirty="0">
                <a:latin typeface="Arial" panose="020B0604020202020204" pitchFamily="34" charset="0"/>
                <a:cs typeface="Arial" panose="020B0604020202020204" pitchFamily="34" charset="0"/>
              </a:rPr>
              <a:t>Nbv6.1trP9009</a:t>
            </a:r>
            <a:endParaRPr lang="ko-KR" altLang="en-US" sz="72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3" name="표 2">
            <a:extLst>
              <a:ext uri="{FF2B5EF4-FFF2-40B4-BE49-F238E27FC236}">
                <a16:creationId xmlns:a16="http://schemas.microsoft.com/office/drawing/2014/main" id="{1FE8FF64-91CA-4DC6-86C0-BB01F2FA0815}"/>
              </a:ext>
            </a:extLst>
          </p:cNvPr>
          <p:cNvGraphicFramePr>
            <a:graphicFrameLocks noGrp="1"/>
          </p:cNvGraphicFramePr>
          <p:nvPr/>
        </p:nvGraphicFramePr>
        <p:xfrm>
          <a:off x="3095833" y="2503543"/>
          <a:ext cx="509463" cy="1905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094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r>
                        <a:rPr lang="en-US" altLang="ko-KR" sz="6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AGO2</a:t>
                      </a:r>
                      <a:endParaRPr lang="ko-KR" altLang="en-US" sz="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469" marR="47469" marT="23781" marB="23781"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4" name="TextBox 13">
            <a:extLst>
              <a:ext uri="{FF2B5EF4-FFF2-40B4-BE49-F238E27FC236}">
                <a16:creationId xmlns:a16="http://schemas.microsoft.com/office/drawing/2014/main" id="{927F73A7-9D38-4BE7-ADAF-721267C324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9885" y="2521129"/>
            <a:ext cx="281354" cy="163443"/>
          </a:xfrm>
          <a:prstGeom prst="rect">
            <a:avLst/>
          </a:prstGeom>
          <a:solidFill>
            <a:schemeClr val="tx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latinLnBrk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latinLnBrk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latinLnBrk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latinLnBrk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latinLnBrk="0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462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</a:t>
            </a:r>
            <a:endParaRPr lang="ko-KR" altLang="en-US" sz="462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화살표: 오른쪽 34">
            <a:extLst>
              <a:ext uri="{FF2B5EF4-FFF2-40B4-BE49-F238E27FC236}">
                <a16:creationId xmlns:a16="http://schemas.microsoft.com/office/drawing/2014/main" id="{9944C7DE-0476-43D1-A97E-126175AD0087}"/>
              </a:ext>
            </a:extLst>
          </p:cNvPr>
          <p:cNvSpPr/>
          <p:nvPr/>
        </p:nvSpPr>
        <p:spPr>
          <a:xfrm>
            <a:off x="2145980" y="2471306"/>
            <a:ext cx="934915" cy="262303"/>
          </a:xfrm>
          <a:prstGeom prst="rightArrow">
            <a:avLst>
              <a:gd name="adj1" fmla="val 50000"/>
              <a:gd name="adj2" fmla="val 73101"/>
            </a:avLst>
          </a:prstGeom>
          <a:solidFill>
            <a:srgbClr val="FF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ko-KR" sz="62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S</a:t>
            </a:r>
            <a:endParaRPr lang="ko-KR" altLang="en-US" sz="623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20">
            <a:extLst>
              <a:ext uri="{FF2B5EF4-FFF2-40B4-BE49-F238E27FC236}">
                <a16:creationId xmlns:a16="http://schemas.microsoft.com/office/drawing/2014/main" id="{882815E4-A465-4937-803D-4557CF048A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8572" y="2324768"/>
            <a:ext cx="896399" cy="20422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latinLnBrk="0">
              <a:lnSpc>
                <a:spcPct val="100000"/>
              </a:lnSpc>
              <a:spcBef>
                <a:spcPct val="0"/>
              </a:spcBef>
              <a:buNone/>
              <a:defRPr/>
            </a:pPr>
            <a:r>
              <a:rPr lang="en-US" altLang="ko-KR" sz="727" dirty="0">
                <a:latin typeface="Arial" panose="020B0604020202020204" pitchFamily="34" charset="0"/>
                <a:cs typeface="Arial" panose="020B0604020202020204" pitchFamily="34" charset="0"/>
              </a:rPr>
              <a:t>35S:NbAGO2 IR</a:t>
            </a:r>
            <a:endParaRPr lang="ko-KR" altLang="en-US" sz="72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8326D554-E48E-4101-A841-7CD2AC0FE951}"/>
              </a:ext>
            </a:extLst>
          </p:cNvPr>
          <p:cNvCxnSpPr>
            <a:cxnSpLocks/>
          </p:cNvCxnSpPr>
          <p:nvPr/>
        </p:nvCxnSpPr>
        <p:spPr>
          <a:xfrm>
            <a:off x="3094083" y="1865800"/>
            <a:ext cx="0" cy="821321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CAE7AA91-F246-44AB-81A0-C6EE45D8205E}"/>
              </a:ext>
            </a:extLst>
          </p:cNvPr>
          <p:cNvCxnSpPr>
            <a:cxnSpLocks/>
          </p:cNvCxnSpPr>
          <p:nvPr/>
        </p:nvCxnSpPr>
        <p:spPr>
          <a:xfrm>
            <a:off x="3608212" y="1872927"/>
            <a:ext cx="0" cy="821321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038163E3-23A9-4B9D-B6AF-04265A6341D8}"/>
              </a:ext>
            </a:extLst>
          </p:cNvPr>
          <p:cNvCxnSpPr>
            <a:cxnSpLocks/>
          </p:cNvCxnSpPr>
          <p:nvPr/>
        </p:nvCxnSpPr>
        <p:spPr>
          <a:xfrm flipH="1">
            <a:off x="1617117" y="2701072"/>
            <a:ext cx="1478717" cy="5411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E8CF9F69-1329-4BE2-BFFC-BC493ADE02F1}"/>
              </a:ext>
            </a:extLst>
          </p:cNvPr>
          <p:cNvCxnSpPr>
            <a:cxnSpLocks/>
          </p:cNvCxnSpPr>
          <p:nvPr/>
        </p:nvCxnSpPr>
        <p:spPr>
          <a:xfrm flipH="1" flipV="1">
            <a:off x="3606567" y="2699109"/>
            <a:ext cx="612570" cy="5510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0" name="표 2">
            <a:extLst>
              <a:ext uri="{FF2B5EF4-FFF2-40B4-BE49-F238E27FC236}">
                <a16:creationId xmlns:a16="http://schemas.microsoft.com/office/drawing/2014/main" id="{D8FCFF0D-3175-4C13-AFD1-3A4D97D7024B}"/>
              </a:ext>
            </a:extLst>
          </p:cNvPr>
          <p:cNvGraphicFramePr>
            <a:graphicFrameLocks noGrp="1"/>
          </p:cNvGraphicFramePr>
          <p:nvPr/>
        </p:nvGraphicFramePr>
        <p:xfrm>
          <a:off x="3889696" y="2503542"/>
          <a:ext cx="509463" cy="1905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094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50000"/>
                        </a:lnSpc>
                      </a:pPr>
                      <a:endParaRPr lang="ko-KR" altLang="en-US" sz="6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469" marR="47469" marT="23781" marB="23781"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43" name="TextBox 42">
            <a:extLst>
              <a:ext uri="{FF2B5EF4-FFF2-40B4-BE49-F238E27FC236}">
                <a16:creationId xmlns:a16="http://schemas.microsoft.com/office/drawing/2014/main" id="{49A679E5-7EAA-4ED0-BCA0-FD9726F08E11}"/>
              </a:ext>
            </a:extLst>
          </p:cNvPr>
          <p:cNvSpPr txBox="1"/>
          <p:nvPr/>
        </p:nvSpPr>
        <p:spPr>
          <a:xfrm rot="10800000">
            <a:off x="3908735" y="2509300"/>
            <a:ext cx="509462" cy="2044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>
              <a:lnSpc>
                <a:spcPct val="150000"/>
              </a:lnSpc>
            </a:pPr>
            <a:r>
              <a:rPr lang="en-US" altLang="ko-KR" sz="554" b="1" dirty="0">
                <a:latin typeface="Arial" panose="020B0604020202020204" pitchFamily="34" charset="0"/>
                <a:cs typeface="Arial" panose="020B0604020202020204" pitchFamily="34" charset="0"/>
              </a:rPr>
              <a:t>NbAGO2</a:t>
            </a:r>
            <a:endParaRPr lang="ko-KR" altLang="en-US" sz="55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그림 53">
            <a:extLst>
              <a:ext uri="{FF2B5EF4-FFF2-40B4-BE49-F238E27FC236}">
                <a16:creationId xmlns:a16="http://schemas.microsoft.com/office/drawing/2014/main" id="{B13209AD-16C3-42E6-A755-E7198789B89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b="86965"/>
          <a:stretch/>
        </p:blipFill>
        <p:spPr>
          <a:xfrm>
            <a:off x="1617117" y="3286466"/>
            <a:ext cx="2602020" cy="379723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DBE37154-5F77-4CDC-9326-28C49CC2BC8E}"/>
              </a:ext>
            </a:extLst>
          </p:cNvPr>
          <p:cNvSpPr txBox="1"/>
          <p:nvPr/>
        </p:nvSpPr>
        <p:spPr>
          <a:xfrm>
            <a:off x="255362" y="1495574"/>
            <a:ext cx="317153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23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9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BC944E5-B25D-48FB-A021-0507FAE13C7B}"/>
              </a:ext>
            </a:extLst>
          </p:cNvPr>
          <p:cNvSpPr txBox="1"/>
          <p:nvPr/>
        </p:nvSpPr>
        <p:spPr>
          <a:xfrm>
            <a:off x="4847859" y="1495574"/>
            <a:ext cx="317153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23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92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166D01E2-6F50-4993-AF48-6778421B8353}"/>
              </a:ext>
            </a:extLst>
          </p:cNvPr>
          <p:cNvGrpSpPr/>
          <p:nvPr/>
        </p:nvGrpSpPr>
        <p:grpSpPr>
          <a:xfrm>
            <a:off x="4979337" y="1628641"/>
            <a:ext cx="3923257" cy="2209937"/>
            <a:chOff x="5433066" y="815082"/>
            <a:chExt cx="4250195" cy="2394098"/>
          </a:xfrm>
        </p:grpSpPr>
        <p:graphicFrame>
          <p:nvGraphicFramePr>
            <p:cNvPr id="60" name="차트 59">
              <a:extLst>
                <a:ext uri="{FF2B5EF4-FFF2-40B4-BE49-F238E27FC236}">
                  <a16:creationId xmlns:a16="http://schemas.microsoft.com/office/drawing/2014/main" id="{68E70554-5DF7-47A3-9201-0DBCA7BD074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39907993"/>
                </p:ext>
              </p:extLst>
            </p:nvPr>
          </p:nvGraphicFramePr>
          <p:xfrm>
            <a:off x="5433066" y="815082"/>
            <a:ext cx="4250195" cy="23940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4BE3BF5-31BE-40D5-8DE2-35A41AD6D581}"/>
                </a:ext>
              </a:extLst>
            </p:cNvPr>
            <p:cNvSpPr txBox="1"/>
            <p:nvPr/>
          </p:nvSpPr>
          <p:spPr>
            <a:xfrm>
              <a:off x="6336441" y="2287016"/>
              <a:ext cx="190406" cy="207696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46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64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7879BB6-69AE-41F2-AA64-7A20507D9259}"/>
                </a:ext>
              </a:extLst>
            </p:cNvPr>
            <p:cNvSpPr txBox="1"/>
            <p:nvPr/>
          </p:nvSpPr>
          <p:spPr>
            <a:xfrm>
              <a:off x="7224677" y="2361016"/>
              <a:ext cx="190406" cy="207696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46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64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E105851-DEF0-479A-AD09-1235F838F8F4}"/>
                </a:ext>
              </a:extLst>
            </p:cNvPr>
            <p:cNvSpPr txBox="1"/>
            <p:nvPr/>
          </p:nvSpPr>
          <p:spPr>
            <a:xfrm>
              <a:off x="8109693" y="2199869"/>
              <a:ext cx="190406" cy="207696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646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64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BFD70152-3892-41B6-8BB2-F2D62887223D}"/>
              </a:ext>
            </a:extLst>
          </p:cNvPr>
          <p:cNvSpPr txBox="1"/>
          <p:nvPr/>
        </p:nvSpPr>
        <p:spPr>
          <a:xfrm>
            <a:off x="324639" y="4772077"/>
            <a:ext cx="8577955" cy="9448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108" b="1" kern="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Figure S1. </a:t>
            </a:r>
            <a:r>
              <a:rPr lang="en-US" altLang="ko-KR" sz="1108" dirty="0">
                <a:latin typeface="Times New Roman" panose="02020603050405020304" pitchFamily="18" charset="0"/>
              </a:rPr>
              <a:t>Silencing of NbAGO2 via transient expression of dsRNA from pRI201 vector. (A) Schematic diagram of the artificial inverted repeat of the NbAGO2 gene. A pair of gene fragments (520 bp, shown in brown) were then placed in a head-to-head orientation across an intron sequence (‘int’) to create an inverted repeat (IR). (B) Relative mRNA levels of AGO2 in </a:t>
            </a:r>
            <a:r>
              <a:rPr lang="en-US" altLang="ko-KR" sz="1108" dirty="0" err="1">
                <a:latin typeface="Times New Roman" panose="02020603050405020304" pitchFamily="18" charset="0"/>
              </a:rPr>
              <a:t>agro</a:t>
            </a:r>
            <a:r>
              <a:rPr lang="en-US" altLang="ko-KR" sz="1108" dirty="0">
                <a:latin typeface="Times New Roman" panose="02020603050405020304" pitchFamily="18" charset="0"/>
              </a:rPr>
              <a:t>-infiltrated discs from </a:t>
            </a:r>
            <a:r>
              <a:rPr lang="en-US" altLang="ko-KR" sz="1108" i="1" dirty="0">
                <a:latin typeface="Times New Roman" panose="02020603050405020304" pitchFamily="18" charset="0"/>
              </a:rPr>
              <a:t>N. </a:t>
            </a:r>
            <a:r>
              <a:rPr lang="en-US" altLang="ko-KR" sz="1108" i="1" dirty="0" err="1">
                <a:latin typeface="Times New Roman" panose="02020603050405020304" pitchFamily="18" charset="0"/>
              </a:rPr>
              <a:t>benthamiana</a:t>
            </a:r>
            <a:r>
              <a:rPr lang="en-US" altLang="ko-KR" sz="1108" i="1" dirty="0">
                <a:latin typeface="Times New Roman" panose="02020603050405020304" pitchFamily="18" charset="0"/>
              </a:rPr>
              <a:t> </a:t>
            </a:r>
            <a:r>
              <a:rPr lang="en-US" altLang="ko-KR" sz="1108" dirty="0">
                <a:latin typeface="Times New Roman" panose="02020603050405020304" pitchFamily="18" charset="0"/>
              </a:rPr>
              <a:t>leaves in comparison with the wild type (WT). The mRNA levels were determined by quantitative RT-PCR and normalized to those of 18S ribosomal RNA. Error bars, standard error of the mean (n = 3). *P &lt; 0.05 (two-sample unequal variance directional t-test).</a:t>
            </a:r>
            <a:endParaRPr lang="ko-KR" altLang="en-US" sz="1108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09775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15E6410E-9C54-6118-3995-BF1EA6566BB7}"/>
              </a:ext>
            </a:extLst>
          </p:cNvPr>
          <p:cNvSpPr txBox="1"/>
          <p:nvPr/>
        </p:nvSpPr>
        <p:spPr>
          <a:xfrm>
            <a:off x="212383" y="978220"/>
            <a:ext cx="2973882" cy="262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108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eroxide</a:t>
            </a:r>
            <a:r>
              <a:rPr lang="ko-KR" altLang="en-US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108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mutase</a:t>
            </a:r>
            <a:r>
              <a:rPr lang="ko-KR" altLang="en-US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(</a:t>
            </a:r>
            <a:r>
              <a:rPr lang="en-US" altLang="ko-KR" sz="1108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SOD1</a:t>
            </a:r>
            <a:r>
              <a:rPr lang="en-US" altLang="ko-KR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10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43C6A242-8BE4-22AE-0245-EA080B827D7F}"/>
              </a:ext>
            </a:extLst>
          </p:cNvPr>
          <p:cNvGrpSpPr/>
          <p:nvPr/>
        </p:nvGrpSpPr>
        <p:grpSpPr>
          <a:xfrm>
            <a:off x="223349" y="1220855"/>
            <a:ext cx="8249296" cy="547441"/>
            <a:chOff x="240320" y="710027"/>
            <a:chExt cx="8936737" cy="593061"/>
          </a:xfrm>
        </p:grpSpPr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9B098344-592F-20FE-708A-C266600D7AE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20044" y="743950"/>
              <a:ext cx="2058162" cy="540926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9F85EA5-6B3D-B63C-9998-2A996BBD5A96}"/>
                </a:ext>
              </a:extLst>
            </p:cNvPr>
            <p:cNvSpPr txBox="1"/>
            <p:nvPr/>
          </p:nvSpPr>
          <p:spPr>
            <a:xfrm>
              <a:off x="3260536" y="710027"/>
              <a:ext cx="760415" cy="22304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a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5C1D194-C661-2CDD-DF07-895B3AE6011E}"/>
                </a:ext>
              </a:extLst>
            </p:cNvPr>
            <p:cNvSpPr txBox="1"/>
            <p:nvPr/>
          </p:nvSpPr>
          <p:spPr>
            <a:xfrm>
              <a:off x="3260536" y="1065527"/>
              <a:ext cx="760415" cy="22304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112C49F4-CFFF-F960-1C7F-97D59869A88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68025" y="762162"/>
              <a:ext cx="2058162" cy="540926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EF23E26-6D5E-5DF8-DDD0-002C54F90364}"/>
                </a:ext>
              </a:extLst>
            </p:cNvPr>
            <p:cNvSpPr txBox="1"/>
            <p:nvPr/>
          </p:nvSpPr>
          <p:spPr>
            <a:xfrm>
              <a:off x="240320" y="713933"/>
              <a:ext cx="760415" cy="22304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D56B65C-858E-7D3B-74B2-88A284152CAA}"/>
                </a:ext>
              </a:extLst>
            </p:cNvPr>
            <p:cNvSpPr txBox="1"/>
            <p:nvPr/>
          </p:nvSpPr>
          <p:spPr>
            <a:xfrm>
              <a:off x="240320" y="1069433"/>
              <a:ext cx="760415" cy="22304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C7A16DB7-8B5D-5B9E-37EB-36D0DC8EC8C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118895" y="762161"/>
              <a:ext cx="2058162" cy="504245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8BA9EB9-6411-5414-E806-CF515A6232A7}"/>
                </a:ext>
              </a:extLst>
            </p:cNvPr>
            <p:cNvSpPr txBox="1"/>
            <p:nvPr/>
          </p:nvSpPr>
          <p:spPr>
            <a:xfrm>
              <a:off x="6312556" y="710027"/>
              <a:ext cx="919517" cy="22304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a-3p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CE4E7E6-3A4B-88BA-C6B7-A94FD831CDDC}"/>
                </a:ext>
              </a:extLst>
            </p:cNvPr>
            <p:cNvSpPr txBox="1"/>
            <p:nvPr/>
          </p:nvSpPr>
          <p:spPr>
            <a:xfrm>
              <a:off x="6312556" y="1065527"/>
              <a:ext cx="760415" cy="22304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02028F90-9D36-8789-B8A1-0AC156C9C969}"/>
              </a:ext>
            </a:extLst>
          </p:cNvPr>
          <p:cNvSpPr txBox="1"/>
          <p:nvPr/>
        </p:nvSpPr>
        <p:spPr>
          <a:xfrm>
            <a:off x="212383" y="2286489"/>
            <a:ext cx="2973882" cy="262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oxide dismutase 3 (</a:t>
            </a:r>
            <a:r>
              <a:rPr lang="en-US" altLang="ko-KR" sz="1108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SOD3</a:t>
            </a:r>
            <a:r>
              <a:rPr lang="en-US" altLang="ko-KR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ko-KR" altLang="en-US" sz="110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F3F2B31-A995-700C-F2D9-6CE1F2BC4E4A}"/>
              </a:ext>
            </a:extLst>
          </p:cNvPr>
          <p:cNvSpPr txBox="1"/>
          <p:nvPr/>
        </p:nvSpPr>
        <p:spPr>
          <a:xfrm>
            <a:off x="222001" y="3594756"/>
            <a:ext cx="7228818" cy="262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per/zinc superoxide dismutase copper chaperone precursor (</a:t>
            </a:r>
            <a:r>
              <a:rPr lang="en-US" altLang="ko-KR" sz="1108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CCS1</a:t>
            </a:r>
            <a:r>
              <a:rPr lang="en-US" altLang="ko-KR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108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4" name="그룹 63">
            <a:extLst>
              <a:ext uri="{FF2B5EF4-FFF2-40B4-BE49-F238E27FC236}">
                <a16:creationId xmlns:a16="http://schemas.microsoft.com/office/drawing/2014/main" id="{0F264D4A-0373-B893-998A-E0B260300EBC}"/>
              </a:ext>
            </a:extLst>
          </p:cNvPr>
          <p:cNvGrpSpPr/>
          <p:nvPr/>
        </p:nvGrpSpPr>
        <p:grpSpPr>
          <a:xfrm>
            <a:off x="223349" y="2497394"/>
            <a:ext cx="8287664" cy="534043"/>
            <a:chOff x="240320" y="2141204"/>
            <a:chExt cx="8978302" cy="578547"/>
          </a:xfrm>
        </p:grpSpPr>
        <p:pic>
          <p:nvPicPr>
            <p:cNvPr id="37" name="그림 36">
              <a:extLst>
                <a:ext uri="{FF2B5EF4-FFF2-40B4-BE49-F238E27FC236}">
                  <a16:creationId xmlns:a16="http://schemas.microsoft.com/office/drawing/2014/main" id="{504F9BD0-7E63-5F2E-514A-AE5A450378F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68025" y="2185865"/>
              <a:ext cx="2056931" cy="504246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BAAED8F6-AC54-DBE2-492F-1ABAE9D8D231}"/>
                </a:ext>
              </a:extLst>
            </p:cNvPr>
            <p:cNvSpPr txBox="1"/>
            <p:nvPr/>
          </p:nvSpPr>
          <p:spPr>
            <a:xfrm>
              <a:off x="240320" y="2141204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84F376F-D52C-54B6-5EA3-6489CBBA107D}"/>
                </a:ext>
              </a:extLst>
            </p:cNvPr>
            <p:cNvSpPr txBox="1"/>
            <p:nvPr/>
          </p:nvSpPr>
          <p:spPr>
            <a:xfrm>
              <a:off x="240320" y="2496703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3DD2ED1-76BC-696A-B581-B24D264BA86B}"/>
                </a:ext>
              </a:extLst>
            </p:cNvPr>
            <p:cNvSpPr txBox="1"/>
            <p:nvPr/>
          </p:nvSpPr>
          <p:spPr>
            <a:xfrm>
              <a:off x="3260536" y="2141204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a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A20DF16-50A1-4858-AC5C-61A18EACBE2E}"/>
                </a:ext>
              </a:extLst>
            </p:cNvPr>
            <p:cNvSpPr txBox="1"/>
            <p:nvPr/>
          </p:nvSpPr>
          <p:spPr>
            <a:xfrm>
              <a:off x="3260536" y="2496703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1D8D95A-3CA3-0C10-6E5F-412471F19AAD}"/>
                </a:ext>
              </a:extLst>
            </p:cNvPr>
            <p:cNvSpPr txBox="1"/>
            <p:nvPr/>
          </p:nvSpPr>
          <p:spPr>
            <a:xfrm>
              <a:off x="6344246" y="2141204"/>
              <a:ext cx="919517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a-3p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93DE595-079D-40A2-09E2-BD219D987F3E}"/>
                </a:ext>
              </a:extLst>
            </p:cNvPr>
            <p:cNvSpPr txBox="1"/>
            <p:nvPr/>
          </p:nvSpPr>
          <p:spPr>
            <a:xfrm>
              <a:off x="6344246" y="2496703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2" name="그림 61">
              <a:extLst>
                <a:ext uri="{FF2B5EF4-FFF2-40B4-BE49-F238E27FC236}">
                  <a16:creationId xmlns:a16="http://schemas.microsoft.com/office/drawing/2014/main" id="{6BA7676C-5765-04E1-606D-9DAA62E229F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160460" y="2185865"/>
              <a:ext cx="2058162" cy="504246"/>
            </a:xfrm>
            <a:prstGeom prst="rect">
              <a:avLst/>
            </a:prstGeom>
          </p:spPr>
        </p:pic>
        <p:pic>
          <p:nvPicPr>
            <p:cNvPr id="63" name="그림 62">
              <a:extLst>
                <a:ext uri="{FF2B5EF4-FFF2-40B4-BE49-F238E27FC236}">
                  <a16:creationId xmlns:a16="http://schemas.microsoft.com/office/drawing/2014/main" id="{3BA11DA1-F14B-654E-228E-2A1561548CE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20044" y="2185865"/>
              <a:ext cx="2056931" cy="504246"/>
            </a:xfrm>
            <a:prstGeom prst="rect">
              <a:avLst/>
            </a:prstGeom>
          </p:spPr>
        </p:pic>
      </p:grpSp>
      <p:grpSp>
        <p:nvGrpSpPr>
          <p:cNvPr id="73" name="그룹 72">
            <a:extLst>
              <a:ext uri="{FF2B5EF4-FFF2-40B4-BE49-F238E27FC236}">
                <a16:creationId xmlns:a16="http://schemas.microsoft.com/office/drawing/2014/main" id="{E2DCE974-DA8A-BA2A-2AFA-44005FBD74B5}"/>
              </a:ext>
            </a:extLst>
          </p:cNvPr>
          <p:cNvGrpSpPr/>
          <p:nvPr/>
        </p:nvGrpSpPr>
        <p:grpSpPr>
          <a:xfrm>
            <a:off x="222002" y="3887083"/>
            <a:ext cx="8250643" cy="534043"/>
            <a:chOff x="243086" y="4313591"/>
            <a:chExt cx="8938196" cy="578547"/>
          </a:xfrm>
        </p:grpSpPr>
        <p:pic>
          <p:nvPicPr>
            <p:cNvPr id="45" name="그림 44">
              <a:extLst>
                <a:ext uri="{FF2B5EF4-FFF2-40B4-BE49-F238E27FC236}">
                  <a16:creationId xmlns:a16="http://schemas.microsoft.com/office/drawing/2014/main" id="{5B21E691-55CF-0496-0B27-6326EDE015C5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68025" y="4358808"/>
              <a:ext cx="2056931" cy="504407"/>
            </a:xfrm>
            <a:prstGeom prst="rect">
              <a:avLst/>
            </a:prstGeom>
          </p:spPr>
        </p:pic>
        <p:pic>
          <p:nvPicPr>
            <p:cNvPr id="47" name="그림 46">
              <a:extLst>
                <a:ext uri="{FF2B5EF4-FFF2-40B4-BE49-F238E27FC236}">
                  <a16:creationId xmlns:a16="http://schemas.microsoft.com/office/drawing/2014/main" id="{E0952617-3351-9D6E-63C7-A5FF8E073A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20043" y="4358002"/>
              <a:ext cx="2056932" cy="506018"/>
            </a:xfrm>
            <a:prstGeom prst="rect">
              <a:avLst/>
            </a:prstGeom>
          </p:spPr>
        </p:pic>
        <p:pic>
          <p:nvPicPr>
            <p:cNvPr id="49" name="그림 48">
              <a:extLst>
                <a:ext uri="{FF2B5EF4-FFF2-40B4-BE49-F238E27FC236}">
                  <a16:creationId xmlns:a16="http://schemas.microsoft.com/office/drawing/2014/main" id="{F7E295C1-5D1C-D2B6-5A05-8B258934A40B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biLevel thresh="50000"/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124351" y="4358002"/>
              <a:ext cx="2056931" cy="506018"/>
            </a:xfrm>
            <a:prstGeom prst="rect">
              <a:avLst/>
            </a:prstGeom>
          </p:spPr>
        </p:pic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584462C-E898-A57A-9DB6-63E38B447809}"/>
                </a:ext>
              </a:extLst>
            </p:cNvPr>
            <p:cNvSpPr txBox="1"/>
            <p:nvPr/>
          </p:nvSpPr>
          <p:spPr>
            <a:xfrm>
              <a:off x="243086" y="4313591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BBDC647-33F0-2CF0-F6E8-1EA805651647}"/>
                </a:ext>
              </a:extLst>
            </p:cNvPr>
            <p:cNvSpPr txBox="1"/>
            <p:nvPr/>
          </p:nvSpPr>
          <p:spPr>
            <a:xfrm>
              <a:off x="243086" y="4669090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76CE83B-0BED-D616-3DBB-0E73B417BEC9}"/>
                </a:ext>
              </a:extLst>
            </p:cNvPr>
            <p:cNvSpPr txBox="1"/>
            <p:nvPr/>
          </p:nvSpPr>
          <p:spPr>
            <a:xfrm>
              <a:off x="3263302" y="4313591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a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8B217EEE-20B9-804D-9E53-FEFF75118618}"/>
                </a:ext>
              </a:extLst>
            </p:cNvPr>
            <p:cNvSpPr txBox="1"/>
            <p:nvPr/>
          </p:nvSpPr>
          <p:spPr>
            <a:xfrm>
              <a:off x="3263302" y="4669090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F6DACE3F-6DA9-499C-CA9C-DE39E9D9B6AE}"/>
                </a:ext>
              </a:extLst>
            </p:cNvPr>
            <p:cNvSpPr txBox="1"/>
            <p:nvPr/>
          </p:nvSpPr>
          <p:spPr>
            <a:xfrm>
              <a:off x="6347012" y="4313591"/>
              <a:ext cx="919517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miRNA398a-3p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3ED7F41C-94ED-56C7-F73D-DB3D36F7DE5A}"/>
                </a:ext>
              </a:extLst>
            </p:cNvPr>
            <p:cNvSpPr txBox="1"/>
            <p:nvPr/>
          </p:nvSpPr>
          <p:spPr>
            <a:xfrm>
              <a:off x="6347012" y="4669090"/>
              <a:ext cx="760415" cy="22304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738" kern="0" dirty="0">
                  <a:solidFill>
                    <a:srgbClr val="333333"/>
                  </a:solidFill>
                  <a:latin typeface="Times New Roman" panose="02020603050405020304" pitchFamily="18" charset="0"/>
                  <a:ea typeface="굴림체" panose="020B0609000101010101" pitchFamily="49" charset="-127"/>
                  <a:cs typeface="Times New Roman" panose="02020603050405020304" pitchFamily="18" charset="0"/>
                </a:rPr>
                <a:t>Target </a:t>
              </a:r>
              <a:endParaRPr lang="ko-KR" altLang="en-US" sz="738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B92F2B54-A019-0363-15C5-1B77AF9F1AA3}"/>
              </a:ext>
            </a:extLst>
          </p:cNvPr>
          <p:cNvSpPr txBox="1"/>
          <p:nvPr/>
        </p:nvSpPr>
        <p:spPr>
          <a:xfrm>
            <a:off x="277028" y="5069085"/>
            <a:ext cx="8140591" cy="7743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108" b="1" kern="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Figure S2. 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In silico analysis of tomato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iR398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iRNA398a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and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iR398a-3p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target genes by </a:t>
            </a:r>
            <a:r>
              <a:rPr lang="en-US" altLang="ko-KR" sz="1108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sRNATarget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software. Nucleotide numbering is indicated for the coding DNA sequences of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lSOD1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Solyc01g067740.3.1),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lSOD3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Solyc11g066390.2.1), and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lCCS1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CCS1, Solyc08g079830.3.1). All three miR398s were found to have target sequences in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lSOD1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lSOD3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nd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lCCS1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but not </a:t>
            </a:r>
            <a:r>
              <a:rPr lang="en-US" altLang="ko-KR" sz="1108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lSOD2 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enes examined. Thermal stability between each </a:t>
            </a:r>
            <a:r>
              <a:rPr lang="en-US" altLang="ko-KR" sz="1108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lSOD</a:t>
            </a:r>
            <a:r>
              <a:rPr lang="en-US" altLang="ko-KR" sz="1108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CCS1) and miR398 were calculated using RNA-fold.</a:t>
            </a:r>
            <a:endParaRPr lang="ko-KR" altLang="en-US" sz="11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30CCB6-2F6E-3EA3-C463-B7F72E0C2A48}"/>
              </a:ext>
            </a:extLst>
          </p:cNvPr>
          <p:cNvSpPr txBox="1"/>
          <p:nvPr/>
        </p:nvSpPr>
        <p:spPr>
          <a:xfrm>
            <a:off x="222003" y="435135"/>
            <a:ext cx="8250643" cy="3481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662" b="1" i="1" dirty="0">
                <a:latin typeface="Times New Roman" panose="02020603050405020304" pitchFamily="18" charset="0"/>
                <a:ea typeface="MS Mincho" panose="02020609040205080304" pitchFamily="49" charset="-128"/>
              </a:rPr>
              <a:t>miRNA398</a:t>
            </a:r>
            <a:r>
              <a:rPr lang="en-US" altLang="ko-KR" sz="1662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, </a:t>
            </a:r>
            <a:r>
              <a:rPr lang="en-US" altLang="ko-KR" sz="1662" b="1" i="1" dirty="0">
                <a:latin typeface="Times New Roman" panose="02020603050405020304" pitchFamily="18" charset="0"/>
                <a:ea typeface="MS Mincho" panose="02020609040205080304" pitchFamily="49" charset="-128"/>
              </a:rPr>
              <a:t>miRNA398a</a:t>
            </a:r>
            <a:r>
              <a:rPr lang="en-US" altLang="ko-KR" sz="1662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and </a:t>
            </a:r>
            <a:r>
              <a:rPr lang="en-US" altLang="ko-KR" sz="1662" b="1" i="1" dirty="0">
                <a:latin typeface="Times New Roman" panose="02020603050405020304" pitchFamily="18" charset="0"/>
                <a:ea typeface="MS Mincho" panose="02020609040205080304" pitchFamily="49" charset="-128"/>
              </a:rPr>
              <a:t>miRNA398a-3p</a:t>
            </a:r>
            <a:r>
              <a:rPr lang="en-US" altLang="ko-KR" sz="1662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target genes by </a:t>
            </a:r>
            <a:r>
              <a:rPr lang="en-US" altLang="ko-KR" sz="1662" b="1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psRNATarget</a:t>
            </a:r>
            <a:r>
              <a:rPr lang="en-US" altLang="ko-KR" sz="1662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 analysis</a:t>
            </a:r>
            <a:endParaRPr lang="ko-KR" altLang="en-US" sz="1662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4B5CAAC-4393-6205-AB46-E728B736D11C}"/>
              </a:ext>
            </a:extLst>
          </p:cNvPr>
          <p:cNvSpPr txBox="1"/>
          <p:nvPr/>
        </p:nvSpPr>
        <p:spPr>
          <a:xfrm>
            <a:off x="0" y="0"/>
            <a:ext cx="220765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85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altLang="ko-KR" sz="1385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385" kern="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34" charset="-127"/>
                <a:cs typeface="Arial" panose="020B0604020202020204" pitchFamily="34" charset="0"/>
              </a:rPr>
              <a:t>Figure S2</a:t>
            </a:r>
            <a:endParaRPr lang="ko-KR" altLang="en-US" sz="138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E0C43D9-5BCA-4267-C36E-0E090F4EF092}"/>
              </a:ext>
            </a:extLst>
          </p:cNvPr>
          <p:cNvSpPr txBox="1"/>
          <p:nvPr/>
        </p:nvSpPr>
        <p:spPr>
          <a:xfrm>
            <a:off x="212383" y="1792321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29.21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2105524-FB7B-AA00-A695-ED922E66E041}"/>
              </a:ext>
            </a:extLst>
          </p:cNvPr>
          <p:cNvSpPr txBox="1"/>
          <p:nvPr/>
        </p:nvSpPr>
        <p:spPr>
          <a:xfrm>
            <a:off x="3009894" y="1792321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31.09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AB51271-8F25-F49F-FD21-B7F826102AA4}"/>
              </a:ext>
            </a:extLst>
          </p:cNvPr>
          <p:cNvSpPr txBox="1"/>
          <p:nvPr/>
        </p:nvSpPr>
        <p:spPr>
          <a:xfrm>
            <a:off x="5807405" y="1792321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28.37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373B654-2BF6-BE0A-66B7-69E9535CEED2}"/>
              </a:ext>
            </a:extLst>
          </p:cNvPr>
          <p:cNvSpPr txBox="1"/>
          <p:nvPr/>
        </p:nvSpPr>
        <p:spPr>
          <a:xfrm>
            <a:off x="212383" y="3031574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27.17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316B2E-32E7-4F8F-2144-0CA6B74DD738}"/>
              </a:ext>
            </a:extLst>
          </p:cNvPr>
          <p:cNvSpPr txBox="1"/>
          <p:nvPr/>
        </p:nvSpPr>
        <p:spPr>
          <a:xfrm>
            <a:off x="3009894" y="3031574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29.81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3B6326-2652-30DA-E843-445FDD68722A}"/>
              </a:ext>
            </a:extLst>
          </p:cNvPr>
          <p:cNvSpPr txBox="1"/>
          <p:nvPr/>
        </p:nvSpPr>
        <p:spPr>
          <a:xfrm>
            <a:off x="5807405" y="3031574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28.94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8205F78-BDE7-1523-1D98-220521BB6ED1}"/>
              </a:ext>
            </a:extLst>
          </p:cNvPr>
          <p:cNvSpPr txBox="1"/>
          <p:nvPr/>
        </p:nvSpPr>
        <p:spPr>
          <a:xfrm>
            <a:off x="212383" y="4438442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27.41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A1E5A4D-2B2C-7195-FD0C-C0DA8B64646C}"/>
              </a:ext>
            </a:extLst>
          </p:cNvPr>
          <p:cNvSpPr txBox="1"/>
          <p:nvPr/>
        </p:nvSpPr>
        <p:spPr>
          <a:xfrm>
            <a:off x="3009894" y="4438442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29.41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0D2666-1F20-F330-71F9-DF0FD00F1F3B}"/>
              </a:ext>
            </a:extLst>
          </p:cNvPr>
          <p:cNvSpPr txBox="1"/>
          <p:nvPr/>
        </p:nvSpPr>
        <p:spPr>
          <a:xfrm>
            <a:off x="5807405" y="4438442"/>
            <a:ext cx="189984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energy : -24.96</a:t>
            </a:r>
            <a:r>
              <a:rPr lang="en-US" altLang="ko-KR" sz="110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cal/mol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12544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7B11F81-4D65-D76B-BD20-6AE531D7AC5B}"/>
              </a:ext>
            </a:extLst>
          </p:cNvPr>
          <p:cNvSpPr txBox="1"/>
          <p:nvPr/>
        </p:nvSpPr>
        <p:spPr>
          <a:xfrm>
            <a:off x="500712" y="4480618"/>
            <a:ext cx="8140591" cy="4321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108" b="1" kern="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Figure S3. </a:t>
            </a:r>
            <a:r>
              <a:rPr lang="en-US" altLang="ko-KR" sz="1100" dirty="0">
                <a:effectLst/>
                <a:latin typeface="Times New Roman" panose="02020603050405020304" pitchFamily="18" charset="0"/>
                <a:ea typeface="MS PGothic" panose="020B0600070205080204" pitchFamily="34" charset="-128"/>
                <a:cs typeface="MS PGothic" panose="020B0600070205080204" pitchFamily="34" charset="-128"/>
              </a:rPr>
              <a:t>Relative expression levels of AGO1 and AGO2 transcripts in transgenic (hpAGO2) and wild-type tomato plants infected with PVXs, compared with mock-infected wild-type plants. *</a:t>
            </a:r>
            <a:r>
              <a:rPr lang="en-US" altLang="ko-KR" sz="1100" i="1" dirty="0">
                <a:effectLst/>
                <a:latin typeface="Times New Roman" panose="02020603050405020304" pitchFamily="18" charset="0"/>
                <a:ea typeface="MS PGothic" panose="020B0600070205080204" pitchFamily="34" charset="-128"/>
                <a:cs typeface="MS PGothic" panose="020B0600070205080204" pitchFamily="34" charset="-128"/>
              </a:rPr>
              <a:t>P &lt; 0.05 </a:t>
            </a:r>
            <a:r>
              <a:rPr lang="en-US" altLang="ko-KR" sz="1100" dirty="0">
                <a:effectLst/>
                <a:latin typeface="Times New Roman" panose="02020603050405020304" pitchFamily="18" charset="0"/>
                <a:ea typeface="MS PGothic" panose="020B0600070205080204" pitchFamily="34" charset="-128"/>
                <a:cs typeface="MS PGothic" panose="020B0600070205080204" pitchFamily="34" charset="-128"/>
              </a:rPr>
              <a:t>vs. wild-type tomato plants (Student’s t-test).</a:t>
            </a:r>
            <a:endParaRPr lang="ko-KR" altLang="ko-KR" sz="1100" dirty="0">
              <a:effectLst/>
              <a:latin typeface="MS PGothic" panose="020B0600070205080204" pitchFamily="34" charset="-128"/>
              <a:ea typeface="MS PGothic" panose="020B0600070205080204" pitchFamily="34" charset="-128"/>
              <a:cs typeface="MS PGothic" panose="020B0600070205080204" pitchFamily="34" charset="-128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6CA158-944C-2BD3-B32F-48D2F4A20FE5}"/>
              </a:ext>
            </a:extLst>
          </p:cNvPr>
          <p:cNvSpPr txBox="1"/>
          <p:nvPr/>
        </p:nvSpPr>
        <p:spPr>
          <a:xfrm>
            <a:off x="0" y="0"/>
            <a:ext cx="220765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85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altLang="ko-KR" sz="1385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385" kern="0" dirty="0">
                <a:solidFill>
                  <a:srgbClr val="000000"/>
                </a:solidFill>
                <a:latin typeface="Arial" panose="020B0604020202020204" pitchFamily="34" charset="0"/>
                <a:ea typeface="맑은 고딕" panose="020B0503020000020004" pitchFamily="34" charset="-127"/>
                <a:cs typeface="Arial" panose="020B0604020202020204" pitchFamily="34" charset="0"/>
              </a:rPr>
              <a:t>Figure S3</a:t>
            </a:r>
            <a:endParaRPr lang="ko-KR" altLang="en-US" sz="138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그룹 18">
            <a:extLst>
              <a:ext uri="{FF2B5EF4-FFF2-40B4-BE49-F238E27FC236}">
                <a16:creationId xmlns:a16="http://schemas.microsoft.com/office/drawing/2014/main" id="{6D8D8AB5-EAE4-4B91-3C9D-4868D9F3ED8E}"/>
              </a:ext>
            </a:extLst>
          </p:cNvPr>
          <p:cNvGrpSpPr/>
          <p:nvPr/>
        </p:nvGrpSpPr>
        <p:grpSpPr>
          <a:xfrm>
            <a:off x="1276138" y="1908060"/>
            <a:ext cx="6193877" cy="1883017"/>
            <a:chOff x="1276138" y="1908060"/>
            <a:chExt cx="6193877" cy="1883017"/>
          </a:xfrm>
        </p:grpSpPr>
        <p:graphicFrame>
          <p:nvGraphicFramePr>
            <p:cNvPr id="55" name="차트 54">
              <a:extLst>
                <a:ext uri="{FF2B5EF4-FFF2-40B4-BE49-F238E27FC236}">
                  <a16:creationId xmlns:a16="http://schemas.microsoft.com/office/drawing/2014/main" id="{461742B8-929B-4C0B-8F81-B2C2121500B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66125391"/>
                </p:ext>
              </p:extLst>
            </p:nvPr>
          </p:nvGraphicFramePr>
          <p:xfrm>
            <a:off x="1276138" y="1915405"/>
            <a:ext cx="2118871" cy="17555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282CA8C7-1C07-4BB7-AB4C-09CD240BDDE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87528" y="2147800"/>
              <a:ext cx="0" cy="53105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6ACC6952-5B47-42F1-BAAB-0A94B5C3D3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84962" y="2150268"/>
              <a:ext cx="679289" cy="99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0F27A23A-DEAC-4435-8165-550D13F37C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63223" y="2151950"/>
              <a:ext cx="0" cy="18613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121942F-FF4D-411A-A105-466D0A2CA000}"/>
                </a:ext>
              </a:extLst>
            </p:cNvPr>
            <p:cNvSpPr txBox="1"/>
            <p:nvPr/>
          </p:nvSpPr>
          <p:spPr>
            <a:xfrm>
              <a:off x="2747642" y="2024886"/>
              <a:ext cx="154655" cy="170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506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50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958A187E-01C4-4C69-93C0-AC52538FBF5C}"/>
                </a:ext>
              </a:extLst>
            </p:cNvPr>
            <p:cNvSpPr txBox="1"/>
            <p:nvPr/>
          </p:nvSpPr>
          <p:spPr>
            <a:xfrm>
              <a:off x="1986960" y="3613465"/>
              <a:ext cx="1267302" cy="177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   hpAGO2.3               Wild type</a:t>
              </a:r>
              <a:r>
                <a:rPr lang="ko-KR" alt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</a:t>
              </a:r>
            </a:p>
          </p:txBody>
        </p:sp>
        <p:cxnSp>
          <p:nvCxnSpPr>
            <p:cNvPr id="124" name="직선 연결선 123">
              <a:extLst>
                <a:ext uri="{FF2B5EF4-FFF2-40B4-BE49-F238E27FC236}">
                  <a16:creationId xmlns:a16="http://schemas.microsoft.com/office/drawing/2014/main" id="{2F78796B-3A3D-462F-B00C-F7DB390D65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45862" y="3608967"/>
              <a:ext cx="5931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직선 연결선 124">
              <a:extLst>
                <a:ext uri="{FF2B5EF4-FFF2-40B4-BE49-F238E27FC236}">
                  <a16:creationId xmlns:a16="http://schemas.microsoft.com/office/drawing/2014/main" id="{809EAA2C-905B-4A9A-8425-BD9D5287A1D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12734" y="3608516"/>
              <a:ext cx="5931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56" name="차트 55">
              <a:extLst>
                <a:ext uri="{FF2B5EF4-FFF2-40B4-BE49-F238E27FC236}">
                  <a16:creationId xmlns:a16="http://schemas.microsoft.com/office/drawing/2014/main" id="{F3F294B2-E0B9-4F74-8464-A53BA341947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79151349"/>
                </p:ext>
              </p:extLst>
            </p:nvPr>
          </p:nvGraphicFramePr>
          <p:xfrm>
            <a:off x="3313641" y="1923132"/>
            <a:ext cx="2118871" cy="17595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8" name="차트 67">
              <a:extLst>
                <a:ext uri="{FF2B5EF4-FFF2-40B4-BE49-F238E27FC236}">
                  <a16:creationId xmlns:a16="http://schemas.microsoft.com/office/drawing/2014/main" id="{7CABEB6A-0BBE-408F-B74F-BE055C5B85E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64401750"/>
                </p:ext>
              </p:extLst>
            </p:nvPr>
          </p:nvGraphicFramePr>
          <p:xfrm>
            <a:off x="5351144" y="1908060"/>
            <a:ext cx="2118871" cy="17629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6A595C3-FDBA-1862-BC19-24B827A51251}"/>
                </a:ext>
              </a:extLst>
            </p:cNvPr>
            <p:cNvSpPr txBox="1"/>
            <p:nvPr/>
          </p:nvSpPr>
          <p:spPr>
            <a:xfrm>
              <a:off x="4042492" y="3608671"/>
              <a:ext cx="1267302" cy="177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   hpAGO2.3               Wild type</a:t>
              </a:r>
              <a:r>
                <a:rPr lang="ko-KR" alt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</a:t>
              </a:r>
            </a:p>
          </p:txBody>
        </p:sp>
        <p:cxnSp>
          <p:nvCxnSpPr>
            <p:cNvPr id="13" name="직선 연결선 12">
              <a:extLst>
                <a:ext uri="{FF2B5EF4-FFF2-40B4-BE49-F238E27FC236}">
                  <a16:creationId xmlns:a16="http://schemas.microsoft.com/office/drawing/2014/main" id="{6149CA6E-C781-9FA0-F3F8-FF115C40B4B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01394" y="3604173"/>
              <a:ext cx="5931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 13">
              <a:extLst>
                <a:ext uri="{FF2B5EF4-FFF2-40B4-BE49-F238E27FC236}">
                  <a16:creationId xmlns:a16="http://schemas.microsoft.com/office/drawing/2014/main" id="{20716400-C814-DCE6-F28F-794E1EEE9E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68266" y="3603722"/>
              <a:ext cx="5931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31D1FBD-E05C-0809-FBF9-EFB065E1B378}"/>
                </a:ext>
              </a:extLst>
            </p:cNvPr>
            <p:cNvSpPr txBox="1"/>
            <p:nvPr/>
          </p:nvSpPr>
          <p:spPr>
            <a:xfrm>
              <a:off x="6084569" y="3608100"/>
              <a:ext cx="1267302" cy="177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   hpAGO2.3               Wild type</a:t>
              </a:r>
              <a:r>
                <a:rPr lang="ko-KR" altLang="en-US" sz="554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</a:t>
              </a:r>
            </a:p>
          </p:txBody>
        </p: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id="{A840C8BF-F262-37F4-B278-601275EA69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743471" y="3603602"/>
              <a:ext cx="5931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22D9AFC7-DAFC-88C5-BD87-1EE2DE66A38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10343" y="3603151"/>
              <a:ext cx="5931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52726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5</TotalTime>
  <Words>569</Words>
  <Application>Microsoft Macintosh PowerPoint</Application>
  <PresentationFormat>画面に合わせる (4:3)</PresentationFormat>
  <Paragraphs>126</Paragraphs>
  <Slides>4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맑은 고딕</vt:lpstr>
      <vt:lpstr>MS PGothic</vt:lpstr>
      <vt:lpstr>Arial</vt:lpstr>
      <vt:lpstr>Calibri</vt:lpstr>
      <vt:lpstr>Calibri Light</vt:lpstr>
      <vt:lpstr>Times New Roman</vt:lpstr>
      <vt:lpstr>Office 테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권준</dc:creator>
  <cp:lastModifiedBy>健二 中原</cp:lastModifiedBy>
  <cp:revision>20</cp:revision>
  <dcterms:created xsi:type="dcterms:W3CDTF">2023-01-03T21:25:14Z</dcterms:created>
  <dcterms:modified xsi:type="dcterms:W3CDTF">2024-05-20T02:45:56Z</dcterms:modified>
</cp:coreProperties>
</file>